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9" r:id="rId4"/>
    <p:sldId id="260" r:id="rId5"/>
    <p:sldId id="261" r:id="rId6"/>
    <p:sldId id="257" r:id="rId7"/>
    <p:sldId id="262" r:id="rId8"/>
    <p:sldId id="263" r:id="rId9"/>
    <p:sldId id="264" r:id="rId10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4" d="100"/>
          <a:sy n="94" d="100"/>
        </p:scale>
        <p:origin x="221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0367AA0-6EC7-415B-93BC-C4EDED7E0A2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07F2951-5434-460A-A4F2-C5C947370D3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1615F80-D4DE-4772-AD40-F7A769497B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C6A57-6FF4-445C-9FCA-4D3A7F4FDB7D}" type="datetimeFigureOut">
              <a:rPr lang="zh-CN" altLang="en-US" smtClean="0"/>
              <a:t>2022/2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AF7D7BA-FE39-46DE-A4E3-13D4745673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48A4602-C64C-41D8-ACC4-B6503103FD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B5E1-200A-4305-BD7D-FD4306D5A4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525985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83651A3-442F-48EC-A0A9-240D378DA8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E395DD0-87A2-49BD-AA21-9A6B56311E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92E7E18-5D59-459C-86B3-C8DCA94166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C6A57-6FF4-445C-9FCA-4D3A7F4FDB7D}" type="datetimeFigureOut">
              <a:rPr lang="zh-CN" altLang="en-US" smtClean="0"/>
              <a:t>2022/2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33DA57C-B5F1-4F4E-98A7-3F701D7D9F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56F5199-44EA-4FA2-8A42-72612586F3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B5E1-200A-4305-BD7D-FD4306D5A4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8752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F9C66CC-44AF-4354-B732-CCCD04EB20B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A46714C-98B5-4E70-8E05-2B4336187D6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EB97994-F8D0-40F2-8A7D-13C3EAD2B7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C6A57-6FF4-445C-9FCA-4D3A7F4FDB7D}" type="datetimeFigureOut">
              <a:rPr lang="zh-CN" altLang="en-US" smtClean="0"/>
              <a:t>2022/2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1E1513A-F2E5-4AF7-B171-98D7853C26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14E7344-B8BA-4EB8-8066-77972F12D6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B5E1-200A-4305-BD7D-FD4306D5A4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33600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1C1DA95-1E84-47D7-9446-7723E29050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A127581-0B4B-48CA-9E11-721F73DB1EC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39710C8-031E-45BD-A131-4AB9C4CD28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C6A57-6FF4-445C-9FCA-4D3A7F4FDB7D}" type="datetimeFigureOut">
              <a:rPr lang="zh-CN" altLang="en-US" smtClean="0"/>
              <a:t>2022/2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DC08CB2-E959-43EF-A4ED-91503CF173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DE53CB8-AAF0-4CA8-902E-EBF0508227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B5E1-200A-4305-BD7D-FD4306D5A4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176682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029CCCF-6E7B-47D4-BECE-7F4DFE07A0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5A85B68-AC03-45DD-8CB5-8DA504A3EB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C3B810E-7BC8-4CCB-B3F0-A36E91EFD2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C6A57-6FF4-445C-9FCA-4D3A7F4FDB7D}" type="datetimeFigureOut">
              <a:rPr lang="zh-CN" altLang="en-US" smtClean="0"/>
              <a:t>2022/2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80F38EC-9D0B-4ECC-8ECC-B01AE02B5B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19F4497-93BB-4781-8AF3-55EC327CF9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B5E1-200A-4305-BD7D-FD4306D5A4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48352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5031D81-1CC3-4435-AE1E-DCF6317728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1F8C23D-38F5-4D20-B694-01809DBE643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5CC997A-C87A-4A74-9B4D-915ADAB4D9F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14492FF-472F-4BA0-96DA-D8D29AB8BE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C6A57-6FF4-445C-9FCA-4D3A7F4FDB7D}" type="datetimeFigureOut">
              <a:rPr lang="zh-CN" altLang="en-US" smtClean="0"/>
              <a:t>2022/2/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067385E-A740-4EB2-B51D-5A6FC1FB6C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476ADA0-9241-421C-99B6-0D697215B0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B5E1-200A-4305-BD7D-FD4306D5A4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969985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CCD5771-C654-47A6-BD98-5C69DC0729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3483E3B-A2B2-4C67-BC55-73A6B6D651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C2F3DC9-7C78-4AEC-A0C4-322B035AFC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1021211D-F0CB-4D05-8183-AC56D6BAA98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D49C6105-61F3-4DAE-8AF4-2BED0347199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C7828A9A-BC71-4C26-AB6C-5AE49A7D47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C6A57-6FF4-445C-9FCA-4D3A7F4FDB7D}" type="datetimeFigureOut">
              <a:rPr lang="zh-CN" altLang="en-US" smtClean="0"/>
              <a:t>2022/2/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08873537-246E-4184-B04A-61912286BB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6973CBEE-90EB-4D27-96A2-A0E27F1E93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B5E1-200A-4305-BD7D-FD4306D5A4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309844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E600342-DCEC-430B-8D2B-12CA6CF94D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81D69B32-F3FB-4CC7-8C6E-2D17B60E2E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C6A57-6FF4-445C-9FCA-4D3A7F4FDB7D}" type="datetimeFigureOut">
              <a:rPr lang="zh-CN" altLang="en-US" smtClean="0"/>
              <a:t>2022/2/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90260758-77F9-45F4-B463-44525C18F0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5934B6A2-81F2-4012-84B2-5BA458D537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B5E1-200A-4305-BD7D-FD4306D5A4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778032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4D2CBD9B-BB96-4667-B7A3-3198F64B56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C6A57-6FF4-445C-9FCA-4D3A7F4FDB7D}" type="datetimeFigureOut">
              <a:rPr lang="zh-CN" altLang="en-US" smtClean="0"/>
              <a:t>2022/2/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D3D692F3-B54D-45D8-9321-B627BE7717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7F865A0-D705-4CC3-948D-B8C73A04F3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B5E1-200A-4305-BD7D-FD4306D5A4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43963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1FC94BF-7E7B-4A99-A996-525EE0B1EC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C464A58-A4A5-41D1-A827-85DB3CEB7DF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49976B2-B925-40CD-9EA0-964D4C6CE9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069FAEA-D11A-4918-BD9B-6D33166BD6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C6A57-6FF4-445C-9FCA-4D3A7F4FDB7D}" type="datetimeFigureOut">
              <a:rPr lang="zh-CN" altLang="en-US" smtClean="0"/>
              <a:t>2022/2/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0E01441-1B5A-46DD-B589-B5069BA416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0752C2B-EA03-4ADE-ACAF-266237086B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B5E1-200A-4305-BD7D-FD4306D5A4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95327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D6CD1D1-0F6C-4EC9-AEA8-4D1AA15ADB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A54880AD-9187-4F46-8559-36CBF117348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E28FA37-1EAA-49E5-B875-A7B72A72B7C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0FBE759-BBE2-46B1-9DB6-9EB5433EA7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C6A57-6FF4-445C-9FCA-4D3A7F4FDB7D}" type="datetimeFigureOut">
              <a:rPr lang="zh-CN" altLang="en-US" smtClean="0"/>
              <a:t>2022/2/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72F1634-4C22-4E56-A875-35096D98B3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3EA834B-5C12-4EAC-A667-2C8425957F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B5E1-200A-4305-BD7D-FD4306D5A4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26378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A4D01814-5946-43FA-8879-37E8094094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3528FD4-1E73-4BD6-A04D-A2B3AA43B9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308EE82-C376-4660-A663-DD988315F28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C6A57-6FF4-445C-9FCA-4D3A7F4FDB7D}" type="datetimeFigureOut">
              <a:rPr lang="zh-CN" altLang="en-US" smtClean="0"/>
              <a:t>2022/2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C299453-78DA-4E78-B630-C80EC65476C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FE9803C-1DFD-42F0-AC4A-FBA386440E7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32B5E1-200A-4305-BD7D-FD4306D5A4F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33019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6C32F240-26A5-4267-8817-295CAA3C27AA}"/>
              </a:ext>
            </a:extLst>
          </p:cNvPr>
          <p:cNvSpPr txBox="1"/>
          <p:nvPr/>
        </p:nvSpPr>
        <p:spPr>
          <a:xfrm>
            <a:off x="166665" y="162160"/>
            <a:ext cx="59073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Figure 1. </a:t>
            </a:r>
            <a:r>
              <a:rPr lang="en-US" altLang="zh-CN" sz="1400" dirty="0"/>
              <a:t>Heterogeneity of the direct comparisons for disease-free survival</a:t>
            </a:r>
            <a:endParaRPr lang="zh-CN" altLang="en-US" sz="1400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11BFACAB-0ACA-4866-96D3-3F129602DAFE}"/>
              </a:ext>
            </a:extLst>
          </p:cNvPr>
          <p:cNvSpPr txBox="1"/>
          <p:nvPr/>
        </p:nvSpPr>
        <p:spPr>
          <a:xfrm>
            <a:off x="2427889" y="1180161"/>
            <a:ext cx="494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(A)</a:t>
            </a:r>
            <a:endParaRPr lang="zh-CN" altLang="en-US" b="1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85C65248-BB03-46F5-BE82-3FE8D3A0F83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27412" y="1877510"/>
            <a:ext cx="7984007" cy="45804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79540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1A0F9106-F784-4F55-A50B-7DC5F2B8DC42}"/>
              </a:ext>
            </a:extLst>
          </p:cNvPr>
          <p:cNvSpPr txBox="1"/>
          <p:nvPr/>
        </p:nvSpPr>
        <p:spPr>
          <a:xfrm>
            <a:off x="2400863" y="882868"/>
            <a:ext cx="478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(B)</a:t>
            </a:r>
            <a:endParaRPr lang="zh-CN" altLang="en-US" b="1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AF1EA5AB-9BA0-4AE6-B31B-C39AFA29F69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36422" y="1394699"/>
            <a:ext cx="7984007" cy="45804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599869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D8816167-60A2-4645-9183-918ABCD2EA8E}"/>
              </a:ext>
            </a:extLst>
          </p:cNvPr>
          <p:cNvSpPr txBox="1"/>
          <p:nvPr/>
        </p:nvSpPr>
        <p:spPr>
          <a:xfrm>
            <a:off x="2418880" y="1067550"/>
            <a:ext cx="4940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(C)</a:t>
            </a:r>
            <a:endParaRPr lang="zh-CN" altLang="en-US" b="1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1EBC2AB8-5CFC-4F9F-8DC8-D0C92DD9ADA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49935" y="1692828"/>
            <a:ext cx="7984007" cy="45804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4623376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78A6C4C7-5869-49E1-B5C3-273AE22FA978}"/>
              </a:ext>
            </a:extLst>
          </p:cNvPr>
          <p:cNvSpPr txBox="1"/>
          <p:nvPr/>
        </p:nvSpPr>
        <p:spPr>
          <a:xfrm>
            <a:off x="2329218" y="644133"/>
            <a:ext cx="5036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(D)</a:t>
            </a:r>
            <a:endParaRPr lang="zh-CN" altLang="en-US" b="1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DEA825A4-6702-4044-8F00-A895A433920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29218" y="1138783"/>
            <a:ext cx="7984007" cy="45804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0725183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A6077C1B-0E9C-4000-9FC9-33B1D00E2D7A}"/>
              </a:ext>
            </a:extLst>
          </p:cNvPr>
          <p:cNvSpPr txBox="1"/>
          <p:nvPr/>
        </p:nvSpPr>
        <p:spPr>
          <a:xfrm>
            <a:off x="2261225" y="702691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(E)</a:t>
            </a:r>
            <a:endParaRPr lang="zh-CN" altLang="en-US" b="1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F0764BCC-75CE-42F9-9578-BBD90E168DE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21112" y="1282925"/>
            <a:ext cx="7984007" cy="45804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1165121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C7463100-E576-44A3-A772-06FBECB8A39A}"/>
              </a:ext>
            </a:extLst>
          </p:cNvPr>
          <p:cNvSpPr txBox="1"/>
          <p:nvPr/>
        </p:nvSpPr>
        <p:spPr>
          <a:xfrm>
            <a:off x="166665" y="162160"/>
            <a:ext cx="54617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/>
              <a:t>Figure 2. </a:t>
            </a:r>
            <a:r>
              <a:rPr lang="en-US" altLang="zh-CN" sz="1400" dirty="0"/>
              <a:t>Heterogeneity of the direct comparisons for overall survival</a:t>
            </a:r>
            <a:endParaRPr lang="zh-CN" altLang="en-US" sz="1400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D0AF3DEB-1C79-4878-BFC1-2B36A6EA7D84}"/>
              </a:ext>
            </a:extLst>
          </p:cNvPr>
          <p:cNvSpPr txBox="1"/>
          <p:nvPr/>
        </p:nvSpPr>
        <p:spPr>
          <a:xfrm>
            <a:off x="2404241" y="822074"/>
            <a:ext cx="609675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/>
              <a:t>(A)</a:t>
            </a:r>
            <a:endParaRPr lang="zh-CN" altLang="en-US" b="1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F0E03ED8-C644-49CF-B003-F864C62F781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89580" y="1418058"/>
            <a:ext cx="7984007" cy="45804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6427529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51D9A04B-C77C-45C8-B833-541DC7F8FF06}"/>
              </a:ext>
            </a:extLst>
          </p:cNvPr>
          <p:cNvSpPr txBox="1"/>
          <p:nvPr/>
        </p:nvSpPr>
        <p:spPr>
          <a:xfrm>
            <a:off x="2368205" y="786039"/>
            <a:ext cx="609675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/>
              <a:t>(B)</a:t>
            </a:r>
            <a:endParaRPr lang="zh-CN" altLang="en-US" b="1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5B703D80-0A66-4929-AEE3-97DB8B630C4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68205" y="1491528"/>
            <a:ext cx="7984007" cy="45804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8912043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872C487D-F9FD-4703-B5FD-77839CE841EF}"/>
              </a:ext>
            </a:extLst>
          </p:cNvPr>
          <p:cNvSpPr txBox="1"/>
          <p:nvPr/>
        </p:nvSpPr>
        <p:spPr>
          <a:xfrm>
            <a:off x="2282621" y="849101"/>
            <a:ext cx="609675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/>
              <a:t>(C)</a:t>
            </a:r>
            <a:endParaRPr lang="zh-CN" altLang="en-US" b="1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5ABBF8B2-253F-4227-BEB0-CA0957A9AF7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63456" y="1428466"/>
            <a:ext cx="7984007" cy="45804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2291319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45AD9CDF-4984-471F-B465-8A2FA750224E}"/>
              </a:ext>
            </a:extLst>
          </p:cNvPr>
          <p:cNvSpPr txBox="1"/>
          <p:nvPr/>
        </p:nvSpPr>
        <p:spPr>
          <a:xfrm>
            <a:off x="1899744" y="1138783"/>
            <a:ext cx="609675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/>
              <a:t>(D)</a:t>
            </a:r>
            <a:endParaRPr lang="zh-CN" altLang="en-US" b="1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22F1B1D3-CB19-48FA-BFE8-43900B9D017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99744" y="1724359"/>
            <a:ext cx="7984007" cy="45804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624861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96</TotalTime>
  <Words>49</Words>
  <Application>Microsoft Office PowerPoint</Application>
  <PresentationFormat>宽屏</PresentationFormat>
  <Paragraphs>11</Paragraphs>
  <Slides>9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9</vt:i4>
      </vt:variant>
    </vt:vector>
  </HeadingPairs>
  <TitlesOfParts>
    <vt:vector size="13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毓文</dc:creator>
  <cp:lastModifiedBy>毓文</cp:lastModifiedBy>
  <cp:revision>15</cp:revision>
  <dcterms:created xsi:type="dcterms:W3CDTF">2022-01-03T08:20:28Z</dcterms:created>
  <dcterms:modified xsi:type="dcterms:W3CDTF">2022-02-04T11:09:51Z</dcterms:modified>
</cp:coreProperties>
</file>